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64490D-5CAA-4DD9-83C2-18BBF9D0CB4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19740F-85B4-4409-9C3B-D44CE8ECA5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39EB39-6868-49B3-A852-8FD39E65BA6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00544D-0A5D-4D31-A3AD-DAD703981C4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077B95-3940-4411-9D9D-1E2E4933D8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87274F-6C15-4628-B855-CBE35B9258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D68DD8-7A99-47C6-905E-9476972601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B35A29-9286-4C94-997C-A064A4F24D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5A0A58-0DC0-467D-94BD-0D0B3EB1B5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45C038-DD15-4C98-A051-E94F1A1E3E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DD1B83-B714-448E-9DC6-E56A64166B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FEE57E-CE18-45C2-89A9-D2DC6BE0A7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A7F6611-3FF0-4198-BAE2-0AA5A695BEB2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990720" y="652320"/>
          <a:ext cx="6991200" cy="5905800"/>
        </p:xfrm>
        <a:graphic>
          <a:graphicData uri="http://schemas.openxmlformats.org/drawingml/2006/table">
            <a:tbl>
              <a:tblPr/>
              <a:tblGrid>
                <a:gridCol w="2220840"/>
                <a:gridCol w="4770360"/>
              </a:tblGrid>
              <a:tr h="150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DS03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uncharacterized hematopoietic stem/progenitor cells protein MDS03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L9A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llagen, type IX, alpha 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6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M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amin A/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KAZALD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Kazal-type serine peptidase inhibitor domain 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48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PAR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ecreted protein, acidic, cysteine-rich (osteonectin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WNT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wingless-type MMTV integration site family, member 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HOBTB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ho-related BTB domain containing 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V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veolin 1, caveolae protein, 22kD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OT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yl-CoA thioesterase 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RASLS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RAS-like suppressor family, member 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80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IF5A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ukaryotic translation initiation factor 5A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KSG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poptosis inhibito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IM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iment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28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ZBED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zinc finger, BED-type containing 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rbonic anhydrase XIII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K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hymidine kinase 1, solub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LC12A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olute carrier family 12 (sodium/potassium/chloride transporters), member 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TMN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tathmin-like 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48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NAPC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mall nuclear RNA activating complex, polypeptide 1, 43kD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6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V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veolin 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R2F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uclear receptor subfamily 2, group F, member 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OXB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omeobox B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AP2K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itogen-activated protein kinase kinase 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48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100A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100 calcium binding protein A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AG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ung cancer metastasis-associated prote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6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OXB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omeobox B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OXB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omeobox B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NFRSF6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umor necrosis factor receptor superfamily, member 6b, decoy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AMP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ysosomal-associated membrane protein 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48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CL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-cell CLL/lymphoma 6 (zinc finger protein 51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L13A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llagen, type XIII, alpha 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6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DK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yclin-dependent kinase 9 (CDC2-related kinase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IF1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ypoxia-inducible factor 1, alpha subunit (basic helix-loop-helix transcription factor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IF4H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ukaryotic translation initiation factor 4H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48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CA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ersica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DM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drenomedull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WDHD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WD repeat and HMG-box DNA binding protein 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26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X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XL receptor tyrosine kin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084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L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nterleukin 18 (interferon-gamma-inducing factor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itle 1"/>
          <p:cNvSpPr/>
          <p:nvPr/>
        </p:nvSpPr>
        <p:spPr>
          <a:xfrm>
            <a:off x="0" y="-36360"/>
            <a:ext cx="2830680" cy="688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table 2 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5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06T09:35:09Z</dcterms:created>
  <dc:creator>Admin</dc:creator>
  <dc:description/>
  <dc:language>en-US</dc:language>
  <cp:lastModifiedBy>Nome utente</cp:lastModifiedBy>
  <dcterms:modified xsi:type="dcterms:W3CDTF">2011-05-23T13:07:48Z</dcterms:modified>
  <cp:revision>256</cp:revision>
  <dc:subject/>
  <dc:title>Diapositiva 1</dc:title>
</cp:coreProperties>
</file>